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57" r:id="rId3"/>
    <p:sldId id="258" r:id="rId4"/>
    <p:sldId id="259" r:id="rId5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52"/>
    <p:restoredTop sz="94079"/>
  </p:normalViewPr>
  <p:slideViewPr>
    <p:cSldViewPr snapToGrid="0">
      <p:cViewPr>
        <p:scale>
          <a:sx n="110" d="100"/>
          <a:sy n="110" d="100"/>
        </p:scale>
        <p:origin x="2296" y="14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F54F0-973C-4AB9-962D-89DF0CCEA320}" type="datetimeFigureOut">
              <a:rPr lang="it-IT" smtClean="0"/>
              <a:t>07/05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7E2AF-C573-4A23-A485-5A93F198E7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265664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F54F0-973C-4AB9-962D-89DF0CCEA320}" type="datetimeFigureOut">
              <a:rPr lang="it-IT" smtClean="0"/>
              <a:t>07/05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7E2AF-C573-4A23-A485-5A93F198E7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0342021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F54F0-973C-4AB9-962D-89DF0CCEA320}" type="datetimeFigureOut">
              <a:rPr lang="it-IT" smtClean="0"/>
              <a:t>07/05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7E2AF-C573-4A23-A485-5A93F198E7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452491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F54F0-973C-4AB9-962D-89DF0CCEA320}" type="datetimeFigureOut">
              <a:rPr lang="it-IT" smtClean="0"/>
              <a:t>07/05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7E2AF-C573-4A23-A485-5A93F198E7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101276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F54F0-973C-4AB9-962D-89DF0CCEA320}" type="datetimeFigureOut">
              <a:rPr lang="it-IT" smtClean="0"/>
              <a:t>07/05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7E2AF-C573-4A23-A485-5A93F198E7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213050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F54F0-973C-4AB9-962D-89DF0CCEA320}" type="datetimeFigureOut">
              <a:rPr lang="it-IT" smtClean="0"/>
              <a:t>07/05/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7E2AF-C573-4A23-A485-5A93F198E7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840737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F54F0-973C-4AB9-962D-89DF0CCEA320}" type="datetimeFigureOut">
              <a:rPr lang="it-IT" smtClean="0"/>
              <a:t>07/05/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7E2AF-C573-4A23-A485-5A93F198E7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6613380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F54F0-973C-4AB9-962D-89DF0CCEA320}" type="datetimeFigureOut">
              <a:rPr lang="it-IT" smtClean="0"/>
              <a:t>07/05/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7E2AF-C573-4A23-A485-5A93F198E7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493814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F54F0-973C-4AB9-962D-89DF0CCEA320}" type="datetimeFigureOut">
              <a:rPr lang="it-IT" smtClean="0"/>
              <a:t>07/05/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7E2AF-C573-4A23-A485-5A93F198E7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175062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F54F0-973C-4AB9-962D-89DF0CCEA320}" type="datetimeFigureOut">
              <a:rPr lang="it-IT" smtClean="0"/>
              <a:t>07/05/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7E2AF-C573-4A23-A485-5A93F198E7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150207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EBF54F0-973C-4AB9-962D-89DF0CCEA320}" type="datetimeFigureOut">
              <a:rPr lang="it-IT" smtClean="0"/>
              <a:t>07/05/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A67E2AF-C573-4A23-A485-5A93F198E7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986797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BF54F0-973C-4AB9-962D-89DF0CCEA320}" type="datetimeFigureOut">
              <a:rPr lang="it-IT" smtClean="0"/>
              <a:t>07/05/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67E2AF-C573-4A23-A485-5A93F198E7FB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24944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magine 3">
            <a:extLst>
              <a:ext uri="{FF2B5EF4-FFF2-40B4-BE49-F238E27FC236}">
                <a16:creationId xmlns:a16="http://schemas.microsoft.com/office/drawing/2014/main" id="{ABA4004F-AC56-4EE6-BC7B-C257D996D44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0556" y="703599"/>
            <a:ext cx="6306744" cy="9108000"/>
          </a:xfrm>
          <a:prstGeom prst="rect">
            <a:avLst/>
          </a:prstGeom>
        </p:spPr>
      </p:pic>
      <p:sp>
        <p:nvSpPr>
          <p:cNvPr id="5" name="Rettangolo 4">
            <a:extLst>
              <a:ext uri="{FF2B5EF4-FFF2-40B4-BE49-F238E27FC236}">
                <a16:creationId xmlns:a16="http://schemas.microsoft.com/office/drawing/2014/main" id="{4093224C-7564-477A-989B-EE923378D9F8}"/>
              </a:ext>
            </a:extLst>
          </p:cNvPr>
          <p:cNvSpPr/>
          <p:nvPr/>
        </p:nvSpPr>
        <p:spPr>
          <a:xfrm>
            <a:off x="79249" y="27726"/>
            <a:ext cx="6306745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b="1" dirty="0">
                <a:solidFill>
                  <a:srgbClr val="000000"/>
                </a:solidFill>
                <a:latin typeface="PalatinoLinotype-Roman"/>
              </a:rPr>
              <a:t>Supplementary Figure S4</a:t>
            </a:r>
            <a:r>
              <a:rPr lang="en-US" sz="1100" dirty="0">
                <a:solidFill>
                  <a:srgbClr val="000000"/>
                </a:solidFill>
                <a:latin typeface="PalatinoLinotype-Roman"/>
              </a:rPr>
              <a:t>: Heat map showing the distribution on the 12 tomato chromosomes of genes affected by SNP/</a:t>
            </a:r>
            <a:r>
              <a:rPr lang="en-US" sz="1100" dirty="0" err="1">
                <a:solidFill>
                  <a:srgbClr val="000000"/>
                </a:solidFill>
                <a:latin typeface="PalatinoLinotype-Roman"/>
              </a:rPr>
              <a:t>InDel</a:t>
            </a:r>
            <a:r>
              <a:rPr lang="en-US" sz="1100" dirty="0">
                <a:solidFill>
                  <a:srgbClr val="000000"/>
                </a:solidFill>
                <a:latin typeface="PalatinoLinotype-Roman"/>
              </a:rPr>
              <a:t> mutations with high and moderate impact. For each mutation, the reference and alternative alleles are reported, together with the position on </a:t>
            </a:r>
            <a:r>
              <a:rPr lang="en-US" sz="1100">
                <a:solidFill>
                  <a:srgbClr val="000000"/>
                </a:solidFill>
                <a:latin typeface="PalatinoLinotype-Roman"/>
              </a:rPr>
              <a:t>the tomato genome (version SL3.0</a:t>
            </a:r>
            <a:r>
              <a:rPr lang="en-US" sz="1100" dirty="0">
                <a:solidFill>
                  <a:srgbClr val="000000"/>
                </a:solidFill>
                <a:latin typeface="PalatinoLinotype-Roman"/>
              </a:rPr>
              <a:t>)</a:t>
            </a:r>
            <a:endParaRPr lang="it-IT" sz="1100" dirty="0"/>
          </a:p>
        </p:txBody>
      </p:sp>
    </p:spTree>
    <p:extLst>
      <p:ext uri="{BB962C8B-B14F-4D97-AF65-F5344CB8AC3E}">
        <p14:creationId xmlns:p14="http://schemas.microsoft.com/office/powerpoint/2010/main" val="170536098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3DFC5962-81D4-437E-8239-2B3D21082B8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9952"/>
          <a:stretch/>
        </p:blipFill>
        <p:spPr>
          <a:xfrm>
            <a:off x="0" y="265583"/>
            <a:ext cx="6858000" cy="89185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881142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E171EE9E-4FE4-4D0B-A95C-F8399D1DB7B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886"/>
            <a:ext cx="6858000" cy="990422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974148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magine 1">
            <a:extLst>
              <a:ext uri="{FF2B5EF4-FFF2-40B4-BE49-F238E27FC236}">
                <a16:creationId xmlns:a16="http://schemas.microsoft.com/office/drawing/2014/main" id="{1FFEAD82-5DC5-43A1-8E05-D14BE220455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b="8656"/>
          <a:stretch/>
        </p:blipFill>
        <p:spPr>
          <a:xfrm>
            <a:off x="0" y="886"/>
            <a:ext cx="6858000" cy="90468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32959316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</TotalTime>
  <Words>52</Words>
  <Application>Microsoft Macintosh PowerPoint</Application>
  <PresentationFormat>A4 (21x29,7 cm)</PresentationFormat>
  <Paragraphs>1</Paragraphs>
  <Slides>4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PalatinoLinotype-Roman</vt:lpstr>
      <vt:lpstr>Tema di Office</vt:lpstr>
      <vt:lpstr>Presentazione standard di PowerPoint</vt:lpstr>
      <vt:lpstr>Presentazione standard di PowerPoint</vt:lpstr>
      <vt:lpstr>Presentazione standard di PowerPoint</vt:lpstr>
      <vt:lpstr>Presentazione standard di PowerPoint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Fabrizio Olivieri</dc:creator>
  <cp:lastModifiedBy>Amalia Barone</cp:lastModifiedBy>
  <cp:revision>3</cp:revision>
  <dcterms:created xsi:type="dcterms:W3CDTF">2020-05-06T13:11:07Z</dcterms:created>
  <dcterms:modified xsi:type="dcterms:W3CDTF">2020-05-07T15:40:48Z</dcterms:modified>
</cp:coreProperties>
</file>